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61610-A32B-4AC1-B508-B19E489D0F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282F1-27CA-41DB-B8CC-4CC02378D2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0D50B-36F3-49F2-AFC6-8C05BEE5B7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276E9-3EA7-44FD-B21B-F564A9E38B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900CB-ED5C-4408-A818-95EDAC0E23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A5A0E-FBAD-4DD4-9878-D83ACD86B8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7CEBC-C74F-431B-94B2-F2CBB2E24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964E8-B639-41C1-B8F3-AA4DA0A698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97A5C-6DE3-4A4F-9791-A8BC9B000D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83636-DBAD-4AB0-BC0B-BD18F8A7CB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2CE8D-1D9E-4F84-9DF9-8691AE80CA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3495D-DCAA-4944-9288-B29CEEE140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3C7ED3-9713-4FC5-8EF2-F9906CE5218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690480" y="3330720"/>
            <a:ext cx="3633840" cy="2695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4978440" y="3321000"/>
            <a:ext cx="3573360" cy="26956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66720" y="484200"/>
            <a:ext cx="3672000" cy="26956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4842000" y="549360"/>
            <a:ext cx="4698720" cy="27194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962000" y="700200"/>
            <a:ext cx="1368720" cy="2887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994360" y="817560"/>
            <a:ext cx="1519200" cy="235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22360" y="3581280"/>
            <a:ext cx="497160" cy="233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283440" y="3581280"/>
            <a:ext cx="726840" cy="219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012200" y="47628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Eukaryo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976200" y="3343320"/>
            <a:ext cx="139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Prokaryo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5800" y="8445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538520" y="8618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6720" y="37260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657680" y="37101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0800000">
            <a:off x="433080" y="1415880"/>
            <a:ext cx="362880" cy="11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0800000">
            <a:off x="539280" y="4298760"/>
            <a:ext cx="362880" cy="11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0800000">
            <a:off x="4610160" y="1469880"/>
            <a:ext cx="362880" cy="119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og(Eucl. dist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0800000">
            <a:off x="4764240" y="4229640"/>
            <a:ext cx="362880" cy="119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og(Eucl. dist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977480" y="2995560"/>
            <a:ext cx="13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eans’ aver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939320" y="5826240"/>
            <a:ext cx="13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eans’ aver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065280" y="3009960"/>
            <a:ext cx="170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og(Means’ averag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992200" y="5826240"/>
            <a:ext cx="170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og(Means’ averag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351960" y="63086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03T12:28:14Z</dcterms:created>
  <dc:creator>ucbcja0</dc:creator>
  <dc:description/>
  <dc:language>en-US</dc:language>
  <cp:lastModifiedBy>ucbcja0</cp:lastModifiedBy>
  <dcterms:modified xsi:type="dcterms:W3CDTF">2007-06-08T15:43:31Z</dcterms:modified>
  <cp:revision>15</cp:revision>
  <dc:subject/>
  <dc:title>Slide 1</dc:title>
</cp:coreProperties>
</file>